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1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34A4D0A-7B4F-4359-BA93-2C13BF74EDA0}" type="doc">
      <dgm:prSet loTypeId="urn:microsoft.com/office/officeart/2005/8/layout/hProcess6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GB"/>
        </a:p>
      </dgm:t>
    </dgm:pt>
    <dgm:pt modelId="{5150DBBA-A014-48FD-9CA4-07146E30F64D}">
      <dgm:prSet phldrT="[Text]"/>
      <dgm:spPr/>
      <dgm:t>
        <a:bodyPr/>
        <a:lstStyle/>
        <a:p>
          <a:r>
            <a:rPr lang="en-GB" dirty="0"/>
            <a:t>AHA Cholesterol </a:t>
          </a:r>
          <a:r>
            <a:rPr lang="en-GB" dirty="0" err="1"/>
            <a:t>CarePlan</a:t>
          </a:r>
          <a:endParaRPr lang="en-GB" dirty="0"/>
        </a:p>
      </dgm:t>
    </dgm:pt>
    <dgm:pt modelId="{DA971BFC-0D7A-4DE0-BDB8-E0F9EE4474A6}" type="parTrans" cxnId="{2C0DDB8A-5159-4638-A132-4CCB2119234A}">
      <dgm:prSet/>
      <dgm:spPr/>
      <dgm:t>
        <a:bodyPr/>
        <a:lstStyle/>
        <a:p>
          <a:endParaRPr lang="en-GB"/>
        </a:p>
      </dgm:t>
    </dgm:pt>
    <dgm:pt modelId="{43A8421F-1BA2-4BC0-9E74-DC3E843731A4}" type="sibTrans" cxnId="{2C0DDB8A-5159-4638-A132-4CCB2119234A}">
      <dgm:prSet/>
      <dgm:spPr/>
      <dgm:t>
        <a:bodyPr/>
        <a:lstStyle/>
        <a:p>
          <a:endParaRPr lang="en-GB"/>
        </a:p>
      </dgm:t>
    </dgm:pt>
    <dgm:pt modelId="{31FBC1D5-391B-444B-B524-94E917D06623}">
      <dgm:prSet phldrT="[Text]"/>
      <dgm:spPr/>
      <dgm:t>
        <a:bodyPr/>
        <a:lstStyle/>
        <a:p>
          <a:r>
            <a:rPr lang="en-GB" dirty="0"/>
            <a:t>Follow up clinical </a:t>
          </a:r>
          <a:r>
            <a:rPr lang="en-GB" dirty="0" smtClean="0"/>
            <a:t>visits at 12 &amp; 24 weeks</a:t>
          </a:r>
          <a:endParaRPr lang="en-GB" dirty="0"/>
        </a:p>
      </dgm:t>
    </dgm:pt>
    <dgm:pt modelId="{7864CD3C-CE53-4E32-BD2C-4C96558ABF97}" type="parTrans" cxnId="{0B361C4D-EA01-4243-A76F-67E4D254019A}">
      <dgm:prSet/>
      <dgm:spPr/>
      <dgm:t>
        <a:bodyPr/>
        <a:lstStyle/>
        <a:p>
          <a:endParaRPr lang="en-GB"/>
        </a:p>
      </dgm:t>
    </dgm:pt>
    <dgm:pt modelId="{BB37BEB6-10FF-4092-B45C-1D58BC0E6A57}" type="sibTrans" cxnId="{0B361C4D-EA01-4243-A76F-67E4D254019A}">
      <dgm:prSet/>
      <dgm:spPr/>
      <dgm:t>
        <a:bodyPr/>
        <a:lstStyle/>
        <a:p>
          <a:endParaRPr lang="en-GB"/>
        </a:p>
      </dgm:t>
    </dgm:pt>
    <dgm:pt modelId="{7E15A40E-EB63-4F19-9FB6-8BC8EAB63B7A}">
      <dgm:prSet phldrT="[Text]"/>
      <dgm:spPr/>
      <dgm:t>
        <a:bodyPr/>
        <a:lstStyle/>
        <a:p>
          <a:endParaRPr lang="en-GB" dirty="0"/>
        </a:p>
      </dgm:t>
    </dgm:pt>
    <dgm:pt modelId="{E773C87C-F0B9-4922-85D5-B701A31C0C8A}" type="parTrans" cxnId="{31064EF3-6143-4BA2-846C-E31A1E126CEB}">
      <dgm:prSet/>
      <dgm:spPr/>
      <dgm:t>
        <a:bodyPr/>
        <a:lstStyle/>
        <a:p>
          <a:endParaRPr lang="en-GB"/>
        </a:p>
      </dgm:t>
    </dgm:pt>
    <dgm:pt modelId="{EA7471FC-5D26-49CE-95D8-A567D819342F}" type="sibTrans" cxnId="{31064EF3-6143-4BA2-846C-E31A1E126CEB}">
      <dgm:prSet/>
      <dgm:spPr/>
      <dgm:t>
        <a:bodyPr/>
        <a:lstStyle/>
        <a:p>
          <a:endParaRPr lang="en-GB"/>
        </a:p>
      </dgm:t>
    </dgm:pt>
    <dgm:pt modelId="{2E4CFC3E-1DC3-431E-9CD7-BE4BF56F5B26}">
      <dgm:prSet phldrT="[Text]"/>
      <dgm:spPr/>
      <dgm:t>
        <a:bodyPr/>
        <a:lstStyle/>
        <a:p>
          <a:endParaRPr lang="en-GB" dirty="0"/>
        </a:p>
      </dgm:t>
    </dgm:pt>
    <dgm:pt modelId="{A7DC3164-4424-48CC-A256-72614D95F963}" type="parTrans" cxnId="{58E4C5E2-84B6-4D91-A7F2-5C2258225E12}">
      <dgm:prSet/>
      <dgm:spPr/>
      <dgm:t>
        <a:bodyPr/>
        <a:lstStyle/>
        <a:p>
          <a:endParaRPr lang="en-US"/>
        </a:p>
      </dgm:t>
    </dgm:pt>
    <dgm:pt modelId="{C58881F9-02A4-4A2D-924A-BEF1361E5DCA}" type="sibTrans" cxnId="{58E4C5E2-84B6-4D91-A7F2-5C2258225E12}">
      <dgm:prSet/>
      <dgm:spPr/>
      <dgm:t>
        <a:bodyPr/>
        <a:lstStyle/>
        <a:p>
          <a:endParaRPr lang="en-US"/>
        </a:p>
      </dgm:t>
    </dgm:pt>
    <dgm:pt modelId="{57F6C132-9116-47D5-B649-218BFE557B40}">
      <dgm:prSet phldrT="[Text]"/>
      <dgm:spPr/>
      <dgm:t>
        <a:bodyPr/>
        <a:lstStyle/>
        <a:p>
          <a:r>
            <a:rPr lang="en-GB" dirty="0"/>
            <a:t>Name</a:t>
          </a:r>
        </a:p>
      </dgm:t>
    </dgm:pt>
    <dgm:pt modelId="{58C7C361-799C-4E35-B0AD-6307CD23FA27}" type="sibTrans" cxnId="{38A10E6E-4538-4E10-8500-0B21A31E76C6}">
      <dgm:prSet/>
      <dgm:spPr/>
      <dgm:t>
        <a:bodyPr/>
        <a:lstStyle/>
        <a:p>
          <a:endParaRPr lang="en-GB"/>
        </a:p>
      </dgm:t>
    </dgm:pt>
    <dgm:pt modelId="{1713CB1F-2096-465B-BAC3-62CF4F341950}" type="parTrans" cxnId="{38A10E6E-4538-4E10-8500-0B21A31E76C6}">
      <dgm:prSet/>
      <dgm:spPr/>
      <dgm:t>
        <a:bodyPr/>
        <a:lstStyle/>
        <a:p>
          <a:endParaRPr lang="en-GB"/>
        </a:p>
      </dgm:t>
    </dgm:pt>
    <dgm:pt modelId="{184825D8-C33A-42BC-9F24-523D837473BC}">
      <dgm:prSet phldrT="[Text]"/>
      <dgm:spPr/>
      <dgm:t>
        <a:bodyPr/>
        <a:lstStyle/>
        <a:p>
          <a:r>
            <a:rPr lang="en-GB" dirty="0"/>
            <a:t>Care plan ?s and </a:t>
          </a:r>
          <a:r>
            <a:rPr lang="en-GB"/>
            <a:t>additional </a:t>
          </a:r>
          <a:r>
            <a:rPr lang="en-GB" smtClean="0"/>
            <a:t>Web </a:t>
          </a:r>
          <a:r>
            <a:rPr lang="en-GB" dirty="0" smtClean="0"/>
            <a:t>app ?s</a:t>
          </a:r>
          <a:endParaRPr lang="en-GB" dirty="0"/>
        </a:p>
      </dgm:t>
    </dgm:pt>
    <dgm:pt modelId="{A00667A2-E3A9-4F29-98DC-B4C6289D1B14}" type="parTrans" cxnId="{33625907-CA49-4E24-95B5-368457921810}">
      <dgm:prSet/>
      <dgm:spPr/>
      <dgm:t>
        <a:bodyPr/>
        <a:lstStyle/>
        <a:p>
          <a:endParaRPr lang="en-US"/>
        </a:p>
      </dgm:t>
    </dgm:pt>
    <dgm:pt modelId="{A75D5347-D9C8-4224-A439-5DC9D23D3AD3}" type="sibTrans" cxnId="{33625907-CA49-4E24-95B5-368457921810}">
      <dgm:prSet/>
      <dgm:spPr/>
      <dgm:t>
        <a:bodyPr/>
        <a:lstStyle/>
        <a:p>
          <a:endParaRPr lang="en-US"/>
        </a:p>
      </dgm:t>
    </dgm:pt>
    <dgm:pt modelId="{C8307401-19FC-42BB-B278-F5E13D884126}">
      <dgm:prSet phldrT="[Text]"/>
      <dgm:spPr/>
      <dgm:t>
        <a:bodyPr/>
        <a:lstStyle/>
        <a:p>
          <a:r>
            <a:rPr lang="en-GB" dirty="0"/>
            <a:t>D.O.B.</a:t>
          </a:r>
        </a:p>
      </dgm:t>
    </dgm:pt>
    <dgm:pt modelId="{5C37288E-ABFA-4D22-B191-AEEE088B9A77}" type="parTrans" cxnId="{43BEFD2B-0A8A-4B07-BF29-BFAAFB01C326}">
      <dgm:prSet/>
      <dgm:spPr/>
      <dgm:t>
        <a:bodyPr/>
        <a:lstStyle/>
        <a:p>
          <a:endParaRPr lang="en-US"/>
        </a:p>
      </dgm:t>
    </dgm:pt>
    <dgm:pt modelId="{43067E4F-35FA-4B0C-A2BA-9433E40CA638}" type="sibTrans" cxnId="{43BEFD2B-0A8A-4B07-BF29-BFAAFB01C326}">
      <dgm:prSet/>
      <dgm:spPr/>
      <dgm:t>
        <a:bodyPr/>
        <a:lstStyle/>
        <a:p>
          <a:endParaRPr lang="en-US"/>
        </a:p>
      </dgm:t>
    </dgm:pt>
    <dgm:pt modelId="{3AF85012-C9CC-41E3-8CBA-BCDC157ABCFB}">
      <dgm:prSet phldrT="[Text]"/>
      <dgm:spPr/>
      <dgm:t>
        <a:bodyPr/>
        <a:lstStyle/>
        <a:p>
          <a:r>
            <a:rPr lang="en-GB" dirty="0"/>
            <a:t>Clinical outcomes</a:t>
          </a:r>
        </a:p>
      </dgm:t>
    </dgm:pt>
    <dgm:pt modelId="{0E8E4A1C-94C4-48E3-A0AD-AAF54105278A}" type="parTrans" cxnId="{13E0C2CF-D2EB-4B8A-9D7F-3E70019570EB}">
      <dgm:prSet/>
      <dgm:spPr/>
      <dgm:t>
        <a:bodyPr/>
        <a:lstStyle/>
        <a:p>
          <a:endParaRPr lang="en-US"/>
        </a:p>
      </dgm:t>
    </dgm:pt>
    <dgm:pt modelId="{E446836F-34BE-4D59-9DD6-6167AAE1892C}" type="sibTrans" cxnId="{13E0C2CF-D2EB-4B8A-9D7F-3E70019570EB}">
      <dgm:prSet/>
      <dgm:spPr/>
      <dgm:t>
        <a:bodyPr/>
        <a:lstStyle/>
        <a:p>
          <a:endParaRPr lang="en-US"/>
        </a:p>
      </dgm:t>
    </dgm:pt>
    <dgm:pt modelId="{B20DE993-EC76-4012-921D-37ACF96121B2}">
      <dgm:prSet phldrT="[Text]"/>
      <dgm:spPr/>
      <dgm:t>
        <a:bodyPr/>
        <a:lstStyle/>
        <a:p>
          <a:r>
            <a:rPr lang="en-GB" dirty="0" smtClean="0"/>
            <a:t>Baseline clinical </a:t>
          </a:r>
          <a:r>
            <a:rPr lang="en-GB" dirty="0"/>
            <a:t>visit</a:t>
          </a:r>
        </a:p>
      </dgm:t>
    </dgm:pt>
    <dgm:pt modelId="{13E580C5-B282-40FF-A8D6-DEB9A487222B}" type="sibTrans" cxnId="{52285C53-D490-4476-BDFC-825228EDAA2F}">
      <dgm:prSet/>
      <dgm:spPr/>
      <dgm:t>
        <a:bodyPr/>
        <a:lstStyle/>
        <a:p>
          <a:endParaRPr lang="en-GB"/>
        </a:p>
      </dgm:t>
    </dgm:pt>
    <dgm:pt modelId="{840D9F93-76D3-4E61-A557-A3FC019B4CFC}" type="parTrans" cxnId="{52285C53-D490-4476-BDFC-825228EDAA2F}">
      <dgm:prSet/>
      <dgm:spPr/>
      <dgm:t>
        <a:bodyPr/>
        <a:lstStyle/>
        <a:p>
          <a:endParaRPr lang="en-GB"/>
        </a:p>
      </dgm:t>
    </dgm:pt>
    <dgm:pt modelId="{07DE7DBE-459C-488B-921C-1798FD60EA0B}">
      <dgm:prSet/>
      <dgm:spPr/>
      <dgm:t>
        <a:bodyPr/>
        <a:lstStyle/>
        <a:p>
          <a:endParaRPr lang="en-GB" dirty="0"/>
        </a:p>
      </dgm:t>
    </dgm:pt>
    <dgm:pt modelId="{382AB4E6-9B94-47B8-88F7-7FB05D9E6319}" type="sibTrans" cxnId="{14C7BF01-B892-4601-A2C9-91EC9FB33D37}">
      <dgm:prSet/>
      <dgm:spPr/>
      <dgm:t>
        <a:bodyPr/>
        <a:lstStyle/>
        <a:p>
          <a:endParaRPr lang="en-GB"/>
        </a:p>
      </dgm:t>
    </dgm:pt>
    <dgm:pt modelId="{B1C441C3-C458-41F7-AC39-47F9F3054A17}" type="parTrans" cxnId="{14C7BF01-B892-4601-A2C9-91EC9FB33D37}">
      <dgm:prSet/>
      <dgm:spPr/>
      <dgm:t>
        <a:bodyPr/>
        <a:lstStyle/>
        <a:p>
          <a:endParaRPr lang="en-GB"/>
        </a:p>
      </dgm:t>
    </dgm:pt>
    <dgm:pt modelId="{1918FBF4-E643-4F52-92A3-95107699BE21}">
      <dgm:prSet/>
      <dgm:spPr/>
      <dgm:t>
        <a:bodyPr/>
        <a:lstStyle/>
        <a:p>
          <a:r>
            <a:rPr lang="en-GB" dirty="0"/>
            <a:t>Mobile Number</a:t>
          </a:r>
        </a:p>
      </dgm:t>
    </dgm:pt>
    <dgm:pt modelId="{EE8BB1CD-A87B-493D-A76E-230B0391702B}" type="sibTrans" cxnId="{03693CC0-4C0C-48F3-B2CF-166E055BF018}">
      <dgm:prSet/>
      <dgm:spPr/>
      <dgm:t>
        <a:bodyPr/>
        <a:lstStyle/>
        <a:p>
          <a:endParaRPr lang="en-US"/>
        </a:p>
      </dgm:t>
    </dgm:pt>
    <dgm:pt modelId="{C5A08192-E9EF-42BF-9B89-D96BA339ACEB}" type="parTrans" cxnId="{03693CC0-4C0C-48F3-B2CF-166E055BF018}">
      <dgm:prSet/>
      <dgm:spPr/>
      <dgm:t>
        <a:bodyPr/>
        <a:lstStyle/>
        <a:p>
          <a:endParaRPr lang="en-US"/>
        </a:p>
      </dgm:t>
    </dgm:pt>
    <dgm:pt modelId="{BE0C1D85-AAFF-420D-BC87-DFFC975AD54E}">
      <dgm:prSet/>
      <dgm:spPr/>
      <dgm:t>
        <a:bodyPr/>
        <a:lstStyle/>
        <a:p>
          <a:r>
            <a:rPr lang="en-GB" dirty="0"/>
            <a:t>Clinical outcomes</a:t>
          </a:r>
        </a:p>
      </dgm:t>
    </dgm:pt>
    <dgm:pt modelId="{BB49430A-9D19-4C13-8854-5C1A4D9A7CCD}" type="sibTrans" cxnId="{3B32DFCF-E29F-4938-862D-F5563BDAFAD0}">
      <dgm:prSet/>
      <dgm:spPr/>
      <dgm:t>
        <a:bodyPr/>
        <a:lstStyle/>
        <a:p>
          <a:endParaRPr lang="en-US"/>
        </a:p>
      </dgm:t>
    </dgm:pt>
    <dgm:pt modelId="{C7EAF8A6-3E2B-4BAD-82E1-820E02717236}" type="parTrans" cxnId="{3B32DFCF-E29F-4938-862D-F5563BDAFAD0}">
      <dgm:prSet/>
      <dgm:spPr/>
      <dgm:t>
        <a:bodyPr/>
        <a:lstStyle/>
        <a:p>
          <a:endParaRPr lang="en-US"/>
        </a:p>
      </dgm:t>
    </dgm:pt>
    <dgm:pt modelId="{39955DF2-2E4B-45FB-ADC2-5CAF6E5F4AB0}">
      <dgm:prSet/>
      <dgm:spPr/>
      <dgm:t>
        <a:bodyPr/>
        <a:lstStyle/>
        <a:p>
          <a:endParaRPr lang="en-GB" dirty="0"/>
        </a:p>
      </dgm:t>
    </dgm:pt>
    <dgm:pt modelId="{C88461C2-401D-4217-866A-99764488615D}" type="sibTrans" cxnId="{93A8FA1D-5D79-4ED6-AD8E-43ADB8893D4B}">
      <dgm:prSet/>
      <dgm:spPr/>
      <dgm:t>
        <a:bodyPr/>
        <a:lstStyle/>
        <a:p>
          <a:endParaRPr lang="en-GB"/>
        </a:p>
      </dgm:t>
    </dgm:pt>
    <dgm:pt modelId="{B22DEC13-D4A3-43AC-A48D-BB57EF54B77B}" type="parTrans" cxnId="{93A8FA1D-5D79-4ED6-AD8E-43ADB8893D4B}">
      <dgm:prSet/>
      <dgm:spPr/>
      <dgm:t>
        <a:bodyPr/>
        <a:lstStyle/>
        <a:p>
          <a:endParaRPr lang="en-GB"/>
        </a:p>
      </dgm:t>
    </dgm:pt>
    <dgm:pt modelId="{FC8AE758-2B09-4196-8FE9-6F67F6BD2C2D}">
      <dgm:prSet/>
      <dgm:spPr/>
      <dgm:t>
        <a:bodyPr/>
        <a:lstStyle/>
        <a:p>
          <a:r>
            <a:rPr lang="en-GB" dirty="0" smtClean="0"/>
            <a:t>Name</a:t>
          </a:r>
          <a:endParaRPr lang="en-GB" dirty="0"/>
        </a:p>
      </dgm:t>
    </dgm:pt>
    <dgm:pt modelId="{2CAC8BBC-3753-4D45-9B63-E42E51C4A9AE}" type="parTrans" cxnId="{9E493F2B-9610-41AA-8105-588783599362}">
      <dgm:prSet/>
      <dgm:spPr/>
      <dgm:t>
        <a:bodyPr/>
        <a:lstStyle/>
        <a:p>
          <a:endParaRPr lang="en-GB"/>
        </a:p>
      </dgm:t>
    </dgm:pt>
    <dgm:pt modelId="{CF129698-BF79-4BED-BAF0-32E041BAAFBB}" type="sibTrans" cxnId="{9E493F2B-9610-41AA-8105-588783599362}">
      <dgm:prSet/>
      <dgm:spPr/>
      <dgm:t>
        <a:bodyPr/>
        <a:lstStyle/>
        <a:p>
          <a:endParaRPr lang="en-GB"/>
        </a:p>
      </dgm:t>
    </dgm:pt>
    <dgm:pt modelId="{049B07E6-379F-4F93-AAC4-B0B26BC5400D}">
      <dgm:prSet/>
      <dgm:spPr/>
      <dgm:t>
        <a:bodyPr/>
        <a:lstStyle/>
        <a:p>
          <a:r>
            <a:rPr lang="en-GB" dirty="0" smtClean="0"/>
            <a:t>Unique ID</a:t>
          </a:r>
          <a:endParaRPr lang="en-GB" dirty="0"/>
        </a:p>
      </dgm:t>
    </dgm:pt>
    <dgm:pt modelId="{3BDA9A0F-164E-4D04-B6ED-C738B0C2D474}" type="parTrans" cxnId="{389245B5-9E6A-4219-81B9-A7F05015889F}">
      <dgm:prSet/>
      <dgm:spPr/>
      <dgm:t>
        <a:bodyPr/>
        <a:lstStyle/>
        <a:p>
          <a:endParaRPr lang="en-GB"/>
        </a:p>
      </dgm:t>
    </dgm:pt>
    <dgm:pt modelId="{B1469DC8-BC17-45FF-9EC1-2641FA1A37E8}" type="sibTrans" cxnId="{389245B5-9E6A-4219-81B9-A7F05015889F}">
      <dgm:prSet/>
      <dgm:spPr/>
      <dgm:t>
        <a:bodyPr/>
        <a:lstStyle/>
        <a:p>
          <a:endParaRPr lang="en-GB"/>
        </a:p>
      </dgm:t>
    </dgm:pt>
    <dgm:pt modelId="{DDB4539C-42BD-483C-B354-AD3972DB1830}" type="pres">
      <dgm:prSet presAssocID="{834A4D0A-7B4F-4359-BA93-2C13BF74EDA0}" presName="theList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D2196A4D-F295-4B49-B2D3-7B36ADB1D0C8}" type="pres">
      <dgm:prSet presAssocID="{B20DE993-EC76-4012-921D-37ACF96121B2}" presName="compNode" presStyleCnt="0"/>
      <dgm:spPr/>
    </dgm:pt>
    <dgm:pt modelId="{D4DEFC61-50E1-4863-810B-725548DCAEF1}" type="pres">
      <dgm:prSet presAssocID="{B20DE993-EC76-4012-921D-37ACF96121B2}" presName="noGeometry" presStyleCnt="0"/>
      <dgm:spPr/>
    </dgm:pt>
    <dgm:pt modelId="{FD5FE5AF-D80B-4FBB-9606-C1B3398D8AC2}" type="pres">
      <dgm:prSet presAssocID="{B20DE993-EC76-4012-921D-37ACF96121B2}" presName="childTextVisible" presStyleLbl="bgAccFollowNode1" presStyleIdx="0" presStyleCnt="3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674AF7A1-B4E1-45FE-8271-D9779195F5D9}" type="pres">
      <dgm:prSet presAssocID="{B20DE993-EC76-4012-921D-37ACF96121B2}" presName="childTextHidden" presStyleLbl="bgAccFollowNode1" presStyleIdx="0" presStyleCnt="3"/>
      <dgm:spPr/>
      <dgm:t>
        <a:bodyPr/>
        <a:lstStyle/>
        <a:p>
          <a:endParaRPr lang="en-GB"/>
        </a:p>
      </dgm:t>
    </dgm:pt>
    <dgm:pt modelId="{AE8C43CD-72A9-4611-AAA1-7A65254F2684}" type="pres">
      <dgm:prSet presAssocID="{B20DE993-EC76-4012-921D-37ACF96121B2}" presName="parentText" presStyleLbl="node1" presStyleIdx="0" presStyleCnt="3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B2582866-5DCA-496D-9BCF-C16385E842E5}" type="pres">
      <dgm:prSet presAssocID="{B20DE993-EC76-4012-921D-37ACF96121B2}" presName="aSpace" presStyleCnt="0"/>
      <dgm:spPr/>
    </dgm:pt>
    <dgm:pt modelId="{59E6896B-4A7C-4074-857B-45A9D4F0F68A}" type="pres">
      <dgm:prSet presAssocID="{5150DBBA-A014-48FD-9CA4-07146E30F64D}" presName="compNode" presStyleCnt="0"/>
      <dgm:spPr/>
    </dgm:pt>
    <dgm:pt modelId="{08FA1EAD-C649-432A-8CA4-5A04CA1B0426}" type="pres">
      <dgm:prSet presAssocID="{5150DBBA-A014-48FD-9CA4-07146E30F64D}" presName="noGeometry" presStyleCnt="0"/>
      <dgm:spPr/>
    </dgm:pt>
    <dgm:pt modelId="{DB921617-3D76-43EA-9080-A6928D957AC0}" type="pres">
      <dgm:prSet presAssocID="{5150DBBA-A014-48FD-9CA4-07146E30F64D}" presName="childTextVisible" presStyleLbl="bgAccFollowNode1" presStyleIdx="1" presStyleCnt="3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D50B4D5-67A0-4F7B-8A36-7FED3A0BADCD}" type="pres">
      <dgm:prSet presAssocID="{5150DBBA-A014-48FD-9CA4-07146E30F64D}" presName="childTextHidden" presStyleLbl="bgAccFollowNode1" presStyleIdx="1" presStyleCnt="3"/>
      <dgm:spPr/>
      <dgm:t>
        <a:bodyPr/>
        <a:lstStyle/>
        <a:p>
          <a:endParaRPr lang="en-GB"/>
        </a:p>
      </dgm:t>
    </dgm:pt>
    <dgm:pt modelId="{DB9C4CDC-829A-4D3A-836C-CB22248CED44}" type="pres">
      <dgm:prSet presAssocID="{5150DBBA-A014-48FD-9CA4-07146E30F64D}" presName="parentText" presStyleLbl="node1" presStyleIdx="1" presStyleCnt="3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A33C1EFC-4304-4BE8-9838-50B03682242F}" type="pres">
      <dgm:prSet presAssocID="{5150DBBA-A014-48FD-9CA4-07146E30F64D}" presName="aSpace" presStyleCnt="0"/>
      <dgm:spPr/>
    </dgm:pt>
    <dgm:pt modelId="{10A02346-F88F-43BF-89F9-F2E597165644}" type="pres">
      <dgm:prSet presAssocID="{31FBC1D5-391B-444B-B524-94E917D06623}" presName="compNode" presStyleCnt="0"/>
      <dgm:spPr/>
    </dgm:pt>
    <dgm:pt modelId="{FC1DD737-B969-4F9D-9752-AA1BCF340654}" type="pres">
      <dgm:prSet presAssocID="{31FBC1D5-391B-444B-B524-94E917D06623}" presName="noGeometry" presStyleCnt="0"/>
      <dgm:spPr/>
    </dgm:pt>
    <dgm:pt modelId="{AAAB698C-F27B-44AE-89C0-200949C3E0BF}" type="pres">
      <dgm:prSet presAssocID="{31FBC1D5-391B-444B-B524-94E917D06623}" presName="childTextVisible" presStyleLbl="bgAccFollowNode1" presStyleIdx="2" presStyleCnt="3" custLinFactNeighborX="189" custLinFactNeighborY="-854">
        <dgm:presLayoutVars>
          <dgm:bulletEnabled val="1"/>
        </dgm:presLayoutVars>
      </dgm:prSet>
      <dgm:spPr/>
      <dgm:t>
        <a:bodyPr/>
        <a:lstStyle/>
        <a:p>
          <a:endParaRPr lang="en-GB"/>
        </a:p>
      </dgm:t>
    </dgm:pt>
    <dgm:pt modelId="{9F3692B1-8F48-42C6-85DF-6227852D481E}" type="pres">
      <dgm:prSet presAssocID="{31FBC1D5-391B-444B-B524-94E917D06623}" presName="childTextHidden" presStyleLbl="bgAccFollowNode1" presStyleIdx="2" presStyleCnt="3"/>
      <dgm:spPr/>
      <dgm:t>
        <a:bodyPr/>
        <a:lstStyle/>
        <a:p>
          <a:endParaRPr lang="en-GB"/>
        </a:p>
      </dgm:t>
    </dgm:pt>
    <dgm:pt modelId="{651066C6-62ED-4D8C-AE28-B19E8DDBBC20}" type="pres">
      <dgm:prSet presAssocID="{31FBC1D5-391B-444B-B524-94E917D06623}" presName="parentText" presStyleLbl="node1" presStyleIdx="2" presStyleCnt="3">
        <dgm:presLayoutVars>
          <dgm:chMax val="1"/>
          <dgm:bulletEnabled val="1"/>
        </dgm:presLayoutVars>
      </dgm:prSet>
      <dgm:spPr/>
      <dgm:t>
        <a:bodyPr/>
        <a:lstStyle/>
        <a:p>
          <a:endParaRPr lang="en-GB"/>
        </a:p>
      </dgm:t>
    </dgm:pt>
  </dgm:ptLst>
  <dgm:cxnLst>
    <dgm:cxn modelId="{93A8FA1D-5D79-4ED6-AD8E-43ADB8893D4B}" srcId="{B20DE993-EC76-4012-921D-37ACF96121B2}" destId="{39955DF2-2E4B-45FB-ADC2-5CAF6E5F4AB0}" srcOrd="5" destOrd="0" parTransId="{B22DEC13-D4A3-43AC-A48D-BB57EF54B77B}" sibTransId="{C88461C2-401D-4217-866A-99764488615D}"/>
    <dgm:cxn modelId="{C790E884-14AB-43D6-BB52-6AB9824C8AF9}" type="presOf" srcId="{39955DF2-2E4B-45FB-ADC2-5CAF6E5F4AB0}" destId="{FD5FE5AF-D80B-4FBB-9606-C1B3398D8AC2}" srcOrd="0" destOrd="5" presId="urn:microsoft.com/office/officeart/2005/8/layout/hProcess6"/>
    <dgm:cxn modelId="{58E4C5E2-84B6-4D91-A7F2-5C2258225E12}" srcId="{5150DBBA-A014-48FD-9CA4-07146E30F64D}" destId="{2E4CFC3E-1DC3-431E-9CD7-BE4BF56F5B26}" srcOrd="0" destOrd="0" parTransId="{A7DC3164-4424-48CC-A256-72614D95F963}" sibTransId="{C58881F9-02A4-4A2D-924A-BEF1361E5DCA}"/>
    <dgm:cxn modelId="{0DC5245C-60B0-4617-A58F-402A201EA951}" type="presOf" srcId="{049B07E6-379F-4F93-AAC4-B0B26BC5400D}" destId="{674AF7A1-B4E1-45FE-8271-D9779195F5D9}" srcOrd="1" destOrd="3" presId="urn:microsoft.com/office/officeart/2005/8/layout/hProcess6"/>
    <dgm:cxn modelId="{DCA3A1D0-8C8D-4CE7-AF9D-64ABD9608761}" type="presOf" srcId="{C8307401-19FC-42BB-B278-F5E13D884126}" destId="{9D50B4D5-67A0-4F7B-8A36-7FED3A0BADCD}" srcOrd="1" destOrd="2" presId="urn:microsoft.com/office/officeart/2005/8/layout/hProcess6"/>
    <dgm:cxn modelId="{69E977A8-94EF-46D1-9396-2113F9F978B4}" type="presOf" srcId="{7E15A40E-EB63-4F19-9FB6-8BC8EAB63B7A}" destId="{9F3692B1-8F48-42C6-85DF-6227852D481E}" srcOrd="1" destOrd="0" presId="urn:microsoft.com/office/officeart/2005/8/layout/hProcess6"/>
    <dgm:cxn modelId="{2C0DDB8A-5159-4638-A132-4CCB2119234A}" srcId="{834A4D0A-7B4F-4359-BA93-2C13BF74EDA0}" destId="{5150DBBA-A014-48FD-9CA4-07146E30F64D}" srcOrd="1" destOrd="0" parTransId="{DA971BFC-0D7A-4DE0-BDB8-E0F9EE4474A6}" sibTransId="{43A8421F-1BA2-4BC0-9E74-DC3E843731A4}"/>
    <dgm:cxn modelId="{8A3C5061-FCFC-4058-9909-BB48FD6E1950}" type="presOf" srcId="{3AF85012-C9CC-41E3-8CBA-BCDC157ABCFB}" destId="{AAAB698C-F27B-44AE-89C0-200949C3E0BF}" srcOrd="0" destOrd="2" presId="urn:microsoft.com/office/officeart/2005/8/layout/hProcess6"/>
    <dgm:cxn modelId="{138FE1A1-0E32-4347-B802-B504676D1F42}" type="presOf" srcId="{B20DE993-EC76-4012-921D-37ACF96121B2}" destId="{AE8C43CD-72A9-4611-AAA1-7A65254F2684}" srcOrd="0" destOrd="0" presId="urn:microsoft.com/office/officeart/2005/8/layout/hProcess6"/>
    <dgm:cxn modelId="{7E757A19-2DED-45AD-AAD9-5298EF461CF8}" type="presOf" srcId="{57F6C132-9116-47D5-B649-218BFE557B40}" destId="{9F3692B1-8F48-42C6-85DF-6227852D481E}" srcOrd="1" destOrd="1" presId="urn:microsoft.com/office/officeart/2005/8/layout/hProcess6"/>
    <dgm:cxn modelId="{3A3F9422-B8DF-4E61-8D02-BEDFFBC7C77B}" type="presOf" srcId="{3AF85012-C9CC-41E3-8CBA-BCDC157ABCFB}" destId="{9F3692B1-8F48-42C6-85DF-6227852D481E}" srcOrd="1" destOrd="2" presId="urn:microsoft.com/office/officeart/2005/8/layout/hProcess6"/>
    <dgm:cxn modelId="{80FF43E9-F286-406D-ACEF-BD95B9020D2C}" type="presOf" srcId="{184825D8-C33A-42BC-9F24-523D837473BC}" destId="{9D50B4D5-67A0-4F7B-8A36-7FED3A0BADCD}" srcOrd="1" destOrd="1" presId="urn:microsoft.com/office/officeart/2005/8/layout/hProcess6"/>
    <dgm:cxn modelId="{A5F227FD-6D60-4B81-A27E-E815E86234D5}" type="presOf" srcId="{2E4CFC3E-1DC3-431E-9CD7-BE4BF56F5B26}" destId="{9D50B4D5-67A0-4F7B-8A36-7FED3A0BADCD}" srcOrd="1" destOrd="0" presId="urn:microsoft.com/office/officeart/2005/8/layout/hProcess6"/>
    <dgm:cxn modelId="{CCCD7BAA-E85C-483E-8CF7-3E3BB516C547}" type="presOf" srcId="{5150DBBA-A014-48FD-9CA4-07146E30F64D}" destId="{DB9C4CDC-829A-4D3A-836C-CB22248CED44}" srcOrd="0" destOrd="0" presId="urn:microsoft.com/office/officeart/2005/8/layout/hProcess6"/>
    <dgm:cxn modelId="{389245B5-9E6A-4219-81B9-A7F05015889F}" srcId="{B20DE993-EC76-4012-921D-37ACF96121B2}" destId="{049B07E6-379F-4F93-AAC4-B0B26BC5400D}" srcOrd="3" destOrd="0" parTransId="{3BDA9A0F-164E-4D04-B6ED-C738B0C2D474}" sibTransId="{B1469DC8-BC17-45FF-9EC1-2641FA1A37E8}"/>
    <dgm:cxn modelId="{3B32DFCF-E29F-4938-862D-F5563BDAFAD0}" srcId="{B20DE993-EC76-4012-921D-37ACF96121B2}" destId="{BE0C1D85-AAFF-420D-BC87-DFFC975AD54E}" srcOrd="4" destOrd="0" parTransId="{C7EAF8A6-3E2B-4BAD-82E1-820E02717236}" sibTransId="{BB49430A-9D19-4C13-8854-5C1A4D9A7CCD}"/>
    <dgm:cxn modelId="{B35F3428-1353-4712-B059-ED94FC221F58}" type="presOf" srcId="{049B07E6-379F-4F93-AAC4-B0B26BC5400D}" destId="{FD5FE5AF-D80B-4FBB-9606-C1B3398D8AC2}" srcOrd="0" destOrd="3" presId="urn:microsoft.com/office/officeart/2005/8/layout/hProcess6"/>
    <dgm:cxn modelId="{0B361C4D-EA01-4243-A76F-67E4D254019A}" srcId="{834A4D0A-7B4F-4359-BA93-2C13BF74EDA0}" destId="{31FBC1D5-391B-444B-B524-94E917D06623}" srcOrd="2" destOrd="0" parTransId="{7864CD3C-CE53-4E32-BD2C-4C96558ABF97}" sibTransId="{BB37BEB6-10FF-4092-B45C-1D58BC0E6A57}"/>
    <dgm:cxn modelId="{0BDDEFA0-1AA4-48B1-ABFA-482357F8F976}" type="presOf" srcId="{39955DF2-2E4B-45FB-ADC2-5CAF6E5F4AB0}" destId="{674AF7A1-B4E1-45FE-8271-D9779195F5D9}" srcOrd="1" destOrd="5" presId="urn:microsoft.com/office/officeart/2005/8/layout/hProcess6"/>
    <dgm:cxn modelId="{2A786BE2-535F-49B2-AA90-D2C4D0E67201}" type="presOf" srcId="{7E15A40E-EB63-4F19-9FB6-8BC8EAB63B7A}" destId="{AAAB698C-F27B-44AE-89C0-200949C3E0BF}" srcOrd="0" destOrd="0" presId="urn:microsoft.com/office/officeart/2005/8/layout/hProcess6"/>
    <dgm:cxn modelId="{13E0C2CF-D2EB-4B8A-9D7F-3E70019570EB}" srcId="{31FBC1D5-391B-444B-B524-94E917D06623}" destId="{3AF85012-C9CC-41E3-8CBA-BCDC157ABCFB}" srcOrd="2" destOrd="0" parTransId="{0E8E4A1C-94C4-48E3-A0AD-AAF54105278A}" sibTransId="{E446836F-34BE-4D59-9DD6-6167AAE1892C}"/>
    <dgm:cxn modelId="{29C7BC74-C149-4018-A6CD-13DC6EB9DCC6}" type="presOf" srcId="{1918FBF4-E643-4F52-92A3-95107699BE21}" destId="{FD5FE5AF-D80B-4FBB-9606-C1B3398D8AC2}" srcOrd="0" destOrd="2" presId="urn:microsoft.com/office/officeart/2005/8/layout/hProcess6"/>
    <dgm:cxn modelId="{B9034FEB-2ECE-4346-B6FC-51B23402573A}" type="presOf" srcId="{07DE7DBE-459C-488B-921C-1798FD60EA0B}" destId="{FD5FE5AF-D80B-4FBB-9606-C1B3398D8AC2}" srcOrd="0" destOrd="0" presId="urn:microsoft.com/office/officeart/2005/8/layout/hProcess6"/>
    <dgm:cxn modelId="{B6166D39-24CC-4BFB-BD57-F270C634C0E5}" type="presOf" srcId="{1918FBF4-E643-4F52-92A3-95107699BE21}" destId="{674AF7A1-B4E1-45FE-8271-D9779195F5D9}" srcOrd="1" destOrd="2" presId="urn:microsoft.com/office/officeart/2005/8/layout/hProcess6"/>
    <dgm:cxn modelId="{C65C0A34-A65E-45C7-9807-21D673DC66B9}" type="presOf" srcId="{834A4D0A-7B4F-4359-BA93-2C13BF74EDA0}" destId="{DDB4539C-42BD-483C-B354-AD3972DB1830}" srcOrd="0" destOrd="0" presId="urn:microsoft.com/office/officeart/2005/8/layout/hProcess6"/>
    <dgm:cxn modelId="{14C7BF01-B892-4601-A2C9-91EC9FB33D37}" srcId="{B20DE993-EC76-4012-921D-37ACF96121B2}" destId="{07DE7DBE-459C-488B-921C-1798FD60EA0B}" srcOrd="0" destOrd="0" parTransId="{B1C441C3-C458-41F7-AC39-47F9F3054A17}" sibTransId="{382AB4E6-9B94-47B8-88F7-7FB05D9E6319}"/>
    <dgm:cxn modelId="{5567DE9F-650E-4031-8A0D-AF8F95DF1210}" type="presOf" srcId="{FC8AE758-2B09-4196-8FE9-6F67F6BD2C2D}" destId="{FD5FE5AF-D80B-4FBB-9606-C1B3398D8AC2}" srcOrd="0" destOrd="1" presId="urn:microsoft.com/office/officeart/2005/8/layout/hProcess6"/>
    <dgm:cxn modelId="{52285C53-D490-4476-BDFC-825228EDAA2F}" srcId="{834A4D0A-7B4F-4359-BA93-2C13BF74EDA0}" destId="{B20DE993-EC76-4012-921D-37ACF96121B2}" srcOrd="0" destOrd="0" parTransId="{840D9F93-76D3-4E61-A557-A3FC019B4CFC}" sibTransId="{13E580C5-B282-40FF-A8D6-DEB9A487222B}"/>
    <dgm:cxn modelId="{5A4F0D83-8F79-4038-89E0-C0102A528D41}" type="presOf" srcId="{31FBC1D5-391B-444B-B524-94E917D06623}" destId="{651066C6-62ED-4D8C-AE28-B19E8DDBBC20}" srcOrd="0" destOrd="0" presId="urn:microsoft.com/office/officeart/2005/8/layout/hProcess6"/>
    <dgm:cxn modelId="{38A10E6E-4538-4E10-8500-0B21A31E76C6}" srcId="{31FBC1D5-391B-444B-B524-94E917D06623}" destId="{57F6C132-9116-47D5-B649-218BFE557B40}" srcOrd="1" destOrd="0" parTransId="{1713CB1F-2096-465B-BAC3-62CF4F341950}" sibTransId="{58C7C361-799C-4E35-B0AD-6307CD23FA27}"/>
    <dgm:cxn modelId="{43BEFD2B-0A8A-4B07-BF29-BFAAFB01C326}" srcId="{5150DBBA-A014-48FD-9CA4-07146E30F64D}" destId="{C8307401-19FC-42BB-B278-F5E13D884126}" srcOrd="2" destOrd="0" parTransId="{5C37288E-ABFA-4D22-B191-AEEE088B9A77}" sibTransId="{43067E4F-35FA-4B0C-A2BA-9433E40CA638}"/>
    <dgm:cxn modelId="{61B8738C-F37E-4991-B7BE-DAE294C9F57B}" type="presOf" srcId="{FC8AE758-2B09-4196-8FE9-6F67F6BD2C2D}" destId="{674AF7A1-B4E1-45FE-8271-D9779195F5D9}" srcOrd="1" destOrd="1" presId="urn:microsoft.com/office/officeart/2005/8/layout/hProcess6"/>
    <dgm:cxn modelId="{40B29C61-C52A-4400-BD29-498BEAFCB2A5}" type="presOf" srcId="{BE0C1D85-AAFF-420D-BC87-DFFC975AD54E}" destId="{FD5FE5AF-D80B-4FBB-9606-C1B3398D8AC2}" srcOrd="0" destOrd="4" presId="urn:microsoft.com/office/officeart/2005/8/layout/hProcess6"/>
    <dgm:cxn modelId="{A746B2B4-2132-49E4-8DD8-B8F5F1E1A6EE}" type="presOf" srcId="{BE0C1D85-AAFF-420D-BC87-DFFC975AD54E}" destId="{674AF7A1-B4E1-45FE-8271-D9779195F5D9}" srcOrd="1" destOrd="4" presId="urn:microsoft.com/office/officeart/2005/8/layout/hProcess6"/>
    <dgm:cxn modelId="{8B686FB5-A648-4D40-B2A1-A80B2B69215F}" type="presOf" srcId="{57F6C132-9116-47D5-B649-218BFE557B40}" destId="{AAAB698C-F27B-44AE-89C0-200949C3E0BF}" srcOrd="0" destOrd="1" presId="urn:microsoft.com/office/officeart/2005/8/layout/hProcess6"/>
    <dgm:cxn modelId="{33625907-CA49-4E24-95B5-368457921810}" srcId="{5150DBBA-A014-48FD-9CA4-07146E30F64D}" destId="{184825D8-C33A-42BC-9F24-523D837473BC}" srcOrd="1" destOrd="0" parTransId="{A00667A2-E3A9-4F29-98DC-B4C6289D1B14}" sibTransId="{A75D5347-D9C8-4224-A439-5DC9D23D3AD3}"/>
    <dgm:cxn modelId="{163B7905-AC8C-4AF4-9C45-6EF68D83B571}" type="presOf" srcId="{184825D8-C33A-42BC-9F24-523D837473BC}" destId="{DB921617-3D76-43EA-9080-A6928D957AC0}" srcOrd="0" destOrd="1" presId="urn:microsoft.com/office/officeart/2005/8/layout/hProcess6"/>
    <dgm:cxn modelId="{9E493F2B-9610-41AA-8105-588783599362}" srcId="{B20DE993-EC76-4012-921D-37ACF96121B2}" destId="{FC8AE758-2B09-4196-8FE9-6F67F6BD2C2D}" srcOrd="1" destOrd="0" parTransId="{2CAC8BBC-3753-4D45-9B63-E42E51C4A9AE}" sibTransId="{CF129698-BF79-4BED-BAF0-32E041BAAFBB}"/>
    <dgm:cxn modelId="{03693CC0-4C0C-48F3-B2CF-166E055BF018}" srcId="{B20DE993-EC76-4012-921D-37ACF96121B2}" destId="{1918FBF4-E643-4F52-92A3-95107699BE21}" srcOrd="2" destOrd="0" parTransId="{C5A08192-E9EF-42BF-9B89-D96BA339ACEB}" sibTransId="{EE8BB1CD-A87B-493D-A76E-230B0391702B}"/>
    <dgm:cxn modelId="{31064EF3-6143-4BA2-846C-E31A1E126CEB}" srcId="{31FBC1D5-391B-444B-B524-94E917D06623}" destId="{7E15A40E-EB63-4F19-9FB6-8BC8EAB63B7A}" srcOrd="0" destOrd="0" parTransId="{E773C87C-F0B9-4922-85D5-B701A31C0C8A}" sibTransId="{EA7471FC-5D26-49CE-95D8-A567D819342F}"/>
    <dgm:cxn modelId="{A4CAC597-AC05-471A-8264-5ECD97D16A8C}" type="presOf" srcId="{C8307401-19FC-42BB-B278-F5E13D884126}" destId="{DB921617-3D76-43EA-9080-A6928D957AC0}" srcOrd="0" destOrd="2" presId="urn:microsoft.com/office/officeart/2005/8/layout/hProcess6"/>
    <dgm:cxn modelId="{12B0A968-BF70-47EF-ACDC-8B52D6F77BBD}" type="presOf" srcId="{07DE7DBE-459C-488B-921C-1798FD60EA0B}" destId="{674AF7A1-B4E1-45FE-8271-D9779195F5D9}" srcOrd="1" destOrd="0" presId="urn:microsoft.com/office/officeart/2005/8/layout/hProcess6"/>
    <dgm:cxn modelId="{76137DDA-2BB9-4302-9CAE-3CA8607DA479}" type="presOf" srcId="{2E4CFC3E-1DC3-431E-9CD7-BE4BF56F5B26}" destId="{DB921617-3D76-43EA-9080-A6928D957AC0}" srcOrd="0" destOrd="0" presId="urn:microsoft.com/office/officeart/2005/8/layout/hProcess6"/>
    <dgm:cxn modelId="{D1CE4E02-43CB-40EA-B290-1613CAA5BDD8}" type="presParOf" srcId="{DDB4539C-42BD-483C-B354-AD3972DB1830}" destId="{D2196A4D-F295-4B49-B2D3-7B36ADB1D0C8}" srcOrd="0" destOrd="0" presId="urn:microsoft.com/office/officeart/2005/8/layout/hProcess6"/>
    <dgm:cxn modelId="{AE847AF6-7DE9-4AC4-9EBC-E4ECFE3F818F}" type="presParOf" srcId="{D2196A4D-F295-4B49-B2D3-7B36ADB1D0C8}" destId="{D4DEFC61-50E1-4863-810B-725548DCAEF1}" srcOrd="0" destOrd="0" presId="urn:microsoft.com/office/officeart/2005/8/layout/hProcess6"/>
    <dgm:cxn modelId="{97505732-EB67-48A1-87E1-9E92A6215457}" type="presParOf" srcId="{D2196A4D-F295-4B49-B2D3-7B36ADB1D0C8}" destId="{FD5FE5AF-D80B-4FBB-9606-C1B3398D8AC2}" srcOrd="1" destOrd="0" presId="urn:microsoft.com/office/officeart/2005/8/layout/hProcess6"/>
    <dgm:cxn modelId="{BB61D5EC-C8C7-45DF-BCEA-53FF68C9665B}" type="presParOf" srcId="{D2196A4D-F295-4B49-B2D3-7B36ADB1D0C8}" destId="{674AF7A1-B4E1-45FE-8271-D9779195F5D9}" srcOrd="2" destOrd="0" presId="urn:microsoft.com/office/officeart/2005/8/layout/hProcess6"/>
    <dgm:cxn modelId="{B2D823C7-9D13-4A9C-ACE2-830862183090}" type="presParOf" srcId="{D2196A4D-F295-4B49-B2D3-7B36ADB1D0C8}" destId="{AE8C43CD-72A9-4611-AAA1-7A65254F2684}" srcOrd="3" destOrd="0" presId="urn:microsoft.com/office/officeart/2005/8/layout/hProcess6"/>
    <dgm:cxn modelId="{D66D3AED-BF1F-432C-8D9B-55393EDD44FA}" type="presParOf" srcId="{DDB4539C-42BD-483C-B354-AD3972DB1830}" destId="{B2582866-5DCA-496D-9BCF-C16385E842E5}" srcOrd="1" destOrd="0" presId="urn:microsoft.com/office/officeart/2005/8/layout/hProcess6"/>
    <dgm:cxn modelId="{D7C748B9-1300-4CB2-8EA5-C00F0303D8D6}" type="presParOf" srcId="{DDB4539C-42BD-483C-B354-AD3972DB1830}" destId="{59E6896B-4A7C-4074-857B-45A9D4F0F68A}" srcOrd="2" destOrd="0" presId="urn:microsoft.com/office/officeart/2005/8/layout/hProcess6"/>
    <dgm:cxn modelId="{9BC6EDF4-2B49-4FBA-90F9-428B29DED383}" type="presParOf" srcId="{59E6896B-4A7C-4074-857B-45A9D4F0F68A}" destId="{08FA1EAD-C649-432A-8CA4-5A04CA1B0426}" srcOrd="0" destOrd="0" presId="urn:microsoft.com/office/officeart/2005/8/layout/hProcess6"/>
    <dgm:cxn modelId="{02642A72-E3E5-4AD0-9B18-7087D358DE87}" type="presParOf" srcId="{59E6896B-4A7C-4074-857B-45A9D4F0F68A}" destId="{DB921617-3D76-43EA-9080-A6928D957AC0}" srcOrd="1" destOrd="0" presId="urn:microsoft.com/office/officeart/2005/8/layout/hProcess6"/>
    <dgm:cxn modelId="{9C91BA82-F172-4C44-BD67-2F89F0E47E77}" type="presParOf" srcId="{59E6896B-4A7C-4074-857B-45A9D4F0F68A}" destId="{9D50B4D5-67A0-4F7B-8A36-7FED3A0BADCD}" srcOrd="2" destOrd="0" presId="urn:microsoft.com/office/officeart/2005/8/layout/hProcess6"/>
    <dgm:cxn modelId="{4A7D43EF-5FC3-4853-8600-19CD7AD73C0E}" type="presParOf" srcId="{59E6896B-4A7C-4074-857B-45A9D4F0F68A}" destId="{DB9C4CDC-829A-4D3A-836C-CB22248CED44}" srcOrd="3" destOrd="0" presId="urn:microsoft.com/office/officeart/2005/8/layout/hProcess6"/>
    <dgm:cxn modelId="{1CFAB03E-8817-40B6-AA28-58853D3BBB79}" type="presParOf" srcId="{DDB4539C-42BD-483C-B354-AD3972DB1830}" destId="{A33C1EFC-4304-4BE8-9838-50B03682242F}" srcOrd="3" destOrd="0" presId="urn:microsoft.com/office/officeart/2005/8/layout/hProcess6"/>
    <dgm:cxn modelId="{CD09CD82-5323-462C-AA25-DB6C821B3E00}" type="presParOf" srcId="{DDB4539C-42BD-483C-B354-AD3972DB1830}" destId="{10A02346-F88F-43BF-89F9-F2E597165644}" srcOrd="4" destOrd="0" presId="urn:microsoft.com/office/officeart/2005/8/layout/hProcess6"/>
    <dgm:cxn modelId="{64A35C98-F62B-42F3-B164-37035EF7BFD9}" type="presParOf" srcId="{10A02346-F88F-43BF-89F9-F2E597165644}" destId="{FC1DD737-B969-4F9D-9752-AA1BCF340654}" srcOrd="0" destOrd="0" presId="urn:microsoft.com/office/officeart/2005/8/layout/hProcess6"/>
    <dgm:cxn modelId="{42FBF61E-60CC-4308-9B90-63F01E3B816F}" type="presParOf" srcId="{10A02346-F88F-43BF-89F9-F2E597165644}" destId="{AAAB698C-F27B-44AE-89C0-200949C3E0BF}" srcOrd="1" destOrd="0" presId="urn:microsoft.com/office/officeart/2005/8/layout/hProcess6"/>
    <dgm:cxn modelId="{B1406292-8A1D-472C-A16D-9E73DE92715D}" type="presParOf" srcId="{10A02346-F88F-43BF-89F9-F2E597165644}" destId="{9F3692B1-8F48-42C6-85DF-6227852D481E}" srcOrd="2" destOrd="0" presId="urn:microsoft.com/office/officeart/2005/8/layout/hProcess6"/>
    <dgm:cxn modelId="{AB258421-2FFB-4ECC-A874-4858CD87E230}" type="presParOf" srcId="{10A02346-F88F-43BF-89F9-F2E597165644}" destId="{651066C6-62ED-4D8C-AE28-B19E8DDBBC20}" srcOrd="3" destOrd="0" presId="urn:microsoft.com/office/officeart/2005/8/layout/hProcess6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D5FE5AF-D80B-4FBB-9606-C1B3398D8AC2}">
      <dsp:nvSpPr>
        <dsp:cNvPr id="0" name=""/>
        <dsp:cNvSpPr/>
      </dsp:nvSpPr>
      <dsp:spPr>
        <a:xfrm>
          <a:off x="661760" y="2197648"/>
          <a:ext cx="2627137" cy="2296449"/>
        </a:xfrm>
        <a:prstGeom prst="rightArrow">
          <a:avLst>
            <a:gd name="adj1" fmla="val 70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3020" tIns="8255" rIns="16510" bIns="8255" numCol="1" spcCol="1270" anchor="ctr" anchorCtr="0">
          <a:noAutofit/>
        </a:bodyPr>
        <a:lstStyle/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3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 smtClean="0"/>
            <a:t>Name</a:t>
          </a:r>
          <a:endParaRPr lang="en-GB" sz="13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Mobile Number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 smtClean="0"/>
            <a:t>Unique ID</a:t>
          </a:r>
          <a:endParaRPr lang="en-GB" sz="13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Clinical outcomes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300" kern="1200" dirty="0"/>
        </a:p>
      </dsp:txBody>
      <dsp:txXfrm>
        <a:off x="1318544" y="2542115"/>
        <a:ext cx="1280729" cy="1607515"/>
      </dsp:txXfrm>
    </dsp:sp>
    <dsp:sp modelId="{AE8C43CD-72A9-4611-AAA1-7A65254F2684}">
      <dsp:nvSpPr>
        <dsp:cNvPr id="0" name=""/>
        <dsp:cNvSpPr/>
      </dsp:nvSpPr>
      <dsp:spPr>
        <a:xfrm>
          <a:off x="4975" y="2689088"/>
          <a:ext cx="1313568" cy="1313568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 smtClean="0"/>
            <a:t>Baseline clinical </a:t>
          </a:r>
          <a:r>
            <a:rPr lang="en-GB" sz="1500" kern="1200" dirty="0"/>
            <a:t>visit</a:t>
          </a:r>
        </a:p>
      </dsp:txBody>
      <dsp:txXfrm>
        <a:off x="197343" y="2881456"/>
        <a:ext cx="928832" cy="928832"/>
      </dsp:txXfrm>
    </dsp:sp>
    <dsp:sp modelId="{DB921617-3D76-43EA-9080-A6928D957AC0}">
      <dsp:nvSpPr>
        <dsp:cNvPr id="0" name=""/>
        <dsp:cNvSpPr/>
      </dsp:nvSpPr>
      <dsp:spPr>
        <a:xfrm>
          <a:off x="4109878" y="2197648"/>
          <a:ext cx="2627137" cy="2296449"/>
        </a:xfrm>
        <a:prstGeom prst="rightArrow">
          <a:avLst>
            <a:gd name="adj1" fmla="val 70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3020" tIns="8255" rIns="16510" bIns="8255" numCol="1" spcCol="1270" anchor="ctr" anchorCtr="0">
          <a:noAutofit/>
        </a:bodyPr>
        <a:lstStyle/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3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Care plan ?s and </a:t>
          </a:r>
          <a:r>
            <a:rPr lang="en-GB" sz="1300" kern="1200"/>
            <a:t>additional </a:t>
          </a:r>
          <a:r>
            <a:rPr lang="en-GB" sz="1300" kern="1200" smtClean="0"/>
            <a:t>Web </a:t>
          </a:r>
          <a:r>
            <a:rPr lang="en-GB" sz="1300" kern="1200" dirty="0" smtClean="0"/>
            <a:t>app ?s</a:t>
          </a:r>
          <a:endParaRPr lang="en-GB" sz="13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D.O.B.</a:t>
          </a:r>
        </a:p>
      </dsp:txBody>
      <dsp:txXfrm>
        <a:off x="4766663" y="2542115"/>
        <a:ext cx="1280729" cy="1607515"/>
      </dsp:txXfrm>
    </dsp:sp>
    <dsp:sp modelId="{DB9C4CDC-829A-4D3A-836C-CB22248CED44}">
      <dsp:nvSpPr>
        <dsp:cNvPr id="0" name=""/>
        <dsp:cNvSpPr/>
      </dsp:nvSpPr>
      <dsp:spPr>
        <a:xfrm>
          <a:off x="3453094" y="2689088"/>
          <a:ext cx="1313568" cy="1313568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/>
            <a:t>AHA Cholesterol </a:t>
          </a:r>
          <a:r>
            <a:rPr lang="en-GB" sz="1500" kern="1200" dirty="0" err="1"/>
            <a:t>CarePlan</a:t>
          </a:r>
          <a:endParaRPr lang="en-GB" sz="1500" kern="1200" dirty="0"/>
        </a:p>
      </dsp:txBody>
      <dsp:txXfrm>
        <a:off x="3645462" y="2881456"/>
        <a:ext cx="928832" cy="928832"/>
      </dsp:txXfrm>
    </dsp:sp>
    <dsp:sp modelId="{AAAB698C-F27B-44AE-89C0-200949C3E0BF}">
      <dsp:nvSpPr>
        <dsp:cNvPr id="0" name=""/>
        <dsp:cNvSpPr/>
      </dsp:nvSpPr>
      <dsp:spPr>
        <a:xfrm>
          <a:off x="7562962" y="2178036"/>
          <a:ext cx="2627137" cy="2296449"/>
        </a:xfrm>
        <a:prstGeom prst="rightArrow">
          <a:avLst>
            <a:gd name="adj1" fmla="val 70000"/>
            <a:gd name="adj2" fmla="val 50000"/>
          </a:avLst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3020" tIns="8255" rIns="16510" bIns="8255" numCol="1" spcCol="1270" anchor="ctr" anchorCtr="0">
          <a:noAutofit/>
        </a:bodyPr>
        <a:lstStyle/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endParaRPr lang="en-GB" sz="1300" kern="1200" dirty="0"/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Name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•"/>
          </a:pPr>
          <a:r>
            <a:rPr lang="en-GB" sz="1300" kern="1200" dirty="0"/>
            <a:t>Clinical outcomes</a:t>
          </a:r>
        </a:p>
      </dsp:txBody>
      <dsp:txXfrm>
        <a:off x="8219747" y="2522503"/>
        <a:ext cx="1280729" cy="1607515"/>
      </dsp:txXfrm>
    </dsp:sp>
    <dsp:sp modelId="{651066C6-62ED-4D8C-AE28-B19E8DDBBC20}">
      <dsp:nvSpPr>
        <dsp:cNvPr id="0" name=""/>
        <dsp:cNvSpPr/>
      </dsp:nvSpPr>
      <dsp:spPr>
        <a:xfrm>
          <a:off x="6901212" y="2689088"/>
          <a:ext cx="1313568" cy="1313568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9525" tIns="9525" rIns="9525" bIns="9525" numCol="1" spcCol="1270" anchor="ctr" anchorCtr="0">
          <a:noAutofit/>
        </a:bodyPr>
        <a:lstStyle/>
        <a:p>
          <a:pPr lvl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GB" sz="1500" kern="1200" dirty="0"/>
            <a:t>Follow up clinical </a:t>
          </a:r>
          <a:r>
            <a:rPr lang="en-GB" sz="1500" kern="1200" dirty="0" smtClean="0"/>
            <a:t>visits at 12 &amp; 24 weeks</a:t>
          </a:r>
          <a:endParaRPr lang="en-GB" sz="1500" kern="1200" dirty="0"/>
        </a:p>
      </dsp:txBody>
      <dsp:txXfrm>
        <a:off x="7093580" y="2881456"/>
        <a:ext cx="928832" cy="92883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Process6">
  <dgm:title val=""/>
  <dgm:desc val=""/>
  <dgm:catLst>
    <dgm:cat type="process" pri="7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  <dgm:cxn modelId="33" srcId="3" destId="31" srcOrd="0" destOrd="0"/>
        <dgm:cxn modelId="34" srcId="3" destId="32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theList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L"/>
          <dgm:param type="nodeHorzAlign" val="l"/>
        </dgm:alg>
      </dgm:if>
      <dgm:else name="Name2">
        <dgm:alg type="lin">
          <dgm:param type="linDir" val="from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Node" refType="w"/>
      <dgm:constr type="h" for="ch" forName="compNode" refType="w" refFor="ch" refForName="compNode" fact="0.7"/>
      <dgm:constr type="ctrY" for="ch" forName="compNode" refType="h" fact="0.5"/>
      <dgm:constr type="w" for="ch" forName="aSpace" refType="w" fact="0.05"/>
      <dgm:constr type="primFontSz" for="des" forName="childTextHidden" op="equ" val="65"/>
      <dgm:constr type="primFontSz" for="des" forName="parentText" op="equ"/>
    </dgm:constrLst>
    <dgm:ruleLst/>
    <dgm:forEach name="aNodeForEach" axis="ch" ptType="node">
      <dgm:layoutNode name="compNode">
        <dgm:alg type="composite">
          <dgm:param type="ar" val="1.43"/>
        </dgm:alg>
        <dgm:shape xmlns:r="http://schemas.openxmlformats.org/officeDocument/2006/relationships" r:blip="">
          <dgm:adjLst/>
        </dgm:shape>
        <dgm:presOf/>
        <dgm:choose name="Name3">
          <dgm:if name="Name4" func="var" arg="dir" op="equ" val="norm">
            <dgm:constrLst>
              <dgm:constr type="w" for="ch" forName="childTextVisible" refType="w" fact="0.8"/>
              <dgm:constr type="h" for="ch" forName="childTextVisible" refType="h"/>
              <dgm:constr type="r" for="ch" forName="childTextVisible" refType="w"/>
              <dgm:constr type="w" for="ch" forName="childTextHidden" refType="w" fact="0.6"/>
              <dgm:constr type="h" for="ch" forName="childTextHidden" refType="h"/>
              <dgm:constr type="r" for="ch" forName="childTextHidden" refType="w"/>
              <dgm:constr type="l" for="ch" forName="parentText"/>
              <dgm:constr type="w" for="ch" forName="parentText" refType="w" fact="0.4"/>
              <dgm:constr type="h" for="ch" forName="parentText" refType="w" refFor="ch" refForName="parentText" op="equ"/>
              <dgm:constr type="ctrY" for="ch" forName="parentText" refType="h" fact="0.5"/>
            </dgm:constrLst>
          </dgm:if>
          <dgm:else name="Name5">
            <dgm:constrLst>
              <dgm:constr type="w" for="ch" forName="childTextVisible" refType="w" fact="0.8"/>
              <dgm:constr type="h" for="ch" forName="childTextVisible" refType="h"/>
              <dgm:constr type="l" for="ch" forName="childTextVisible"/>
              <dgm:constr type="w" for="ch" forName="childTextHidden" refType="w" fact="0.6"/>
              <dgm:constr type="h" for="ch" forName="childTextHidden" refType="h"/>
              <dgm:constr type="l" for="ch" forName="childTextHidden"/>
              <dgm:constr type="r" for="ch" forName="parentText" refType="w"/>
              <dgm:constr type="w" for="ch" forName="parentText" refType="w" fact="0.4"/>
              <dgm:constr type="h" for="ch" forName="parentText" refType="w" refFor="ch" refForName="parentText" op="equ"/>
              <dgm:constr type="ctrY" for="ch" forName="parentText" refType="h" fact="0.5"/>
            </dgm:constrLst>
          </dgm:else>
        </dgm:choose>
        <dgm:ruleLst/>
        <dgm:layoutNode name="noGeometry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  <dgm:layoutNode name="childTextVisible" styleLbl="bgAccFollowNode1">
          <dgm:varLst>
            <dgm:bulletEnabled val="1"/>
          </dgm:varLst>
          <dgm:alg type="sp"/>
          <dgm:choose name="Name6">
            <dgm:if name="Name7" func="var" arg="dir" op="equ" val="norm">
              <dgm:shape xmlns:r="http://schemas.openxmlformats.org/officeDocument/2006/relationships" type="rightArrow" r:blip="">
                <dgm:adjLst>
                  <dgm:adj idx="1" val="0.7"/>
                  <dgm:adj idx="2" val="0.5"/>
                </dgm:adjLst>
              </dgm:shape>
            </dgm:if>
            <dgm:else name="Name8">
              <dgm:shape xmlns:r="http://schemas.openxmlformats.org/officeDocument/2006/relationships" type="leftArrow" r:blip="">
                <dgm:adjLst>
                  <dgm:adj idx="1" val="0.7"/>
                  <dgm:adj idx="2" val="0.5"/>
                </dgm:adjLst>
              </dgm:shape>
            </dgm:else>
          </dgm:choose>
          <dgm:presOf axis="des" ptType="node"/>
          <dgm:constrLst/>
          <dgm:ruleLst/>
        </dgm:layoutNode>
        <dgm:layoutNode name="childTextHidden" styleLbl="bgAccFollowNode1">
          <dgm:choose name="Name9">
            <dgm:if name="Name10" axis="des followSib" ptType="node node" st="1 1" cnt="1 0" func="cnt" op="gte" val="1">
              <dgm:alg type="tx">
                <dgm:param type="stBulletLvl" val="1"/>
                <dgm:param type="txAnchorVertCh" val="mid"/>
              </dgm:alg>
            </dgm:if>
            <dgm:else name="Name11">
              <dgm:alg type="tx">
                <dgm:param type="stBulletLvl" val="2"/>
                <dgm:param type="txAnchorVertCh" val="mid"/>
              </dgm:alg>
            </dgm:else>
          </dgm:choose>
          <dgm:choose name="Name12">
            <dgm:if name="Name13" func="var" arg="dir" op="equ" val="norm">
              <dgm:shape xmlns:r="http://schemas.openxmlformats.org/officeDocument/2006/relationships" type="rightArrow" r:blip="" hideGeom="1">
                <dgm:adjLst>
                  <dgm:adj idx="1" val="0.7"/>
                  <dgm:adj idx="2" val="0.5"/>
                </dgm:adjLst>
              </dgm:shape>
            </dgm:if>
            <dgm:else name="Name14">
              <dgm:shape xmlns:r="http://schemas.openxmlformats.org/officeDocument/2006/relationships" type="leftArrow" r:blip="" hideGeom="1">
                <dgm:adjLst>
                  <dgm:adj idx="1" val="0.7"/>
                  <dgm:adj idx="2" val="0.5"/>
                </dgm:adjLst>
              </dgm:shape>
            </dgm:else>
          </dgm:choose>
          <dgm:presOf axis="des" ptType="node"/>
          <dgm:constrLst>
            <dgm:constr type="secFontSz" refType="primFontSz"/>
            <dgm:constr type="tMarg" refType="primFontSz" fact="0.05"/>
            <dgm:constr type="bMarg" refType="primFontSz" fact="0.05"/>
            <dgm:constr type="rMarg" refType="primFontSz" fact="0.1"/>
            <dgm:constr type="lMarg" refType="primFontSz" fact="0.2"/>
          </dgm:constrLst>
          <dgm:ruleLst>
            <dgm:rule type="primFontSz" val="5" fact="NaN" max="NaN"/>
          </dgm:ruleLst>
        </dgm:layoutNode>
        <dgm:layoutNode name="parentText" styleLbl="node1">
          <dgm:varLst>
            <dgm:chMax val="1"/>
            <dgm:bulletEnabled val="1"/>
          </dgm:varLst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primFontSz" val="65"/>
            <dgm:constr type="tMarg" refType="primFontSz" fact="0.05"/>
            <dgm:constr type="bMarg" refType="primFontSz" fact="0.05"/>
            <dgm:constr type="lMarg" refType="primFontSz" fact="0.05"/>
            <dgm:constr type="rMarg" refType="primFontSz" fact="0.05"/>
          </dgm:constrLst>
          <dgm:ruleLst>
            <dgm:rule type="primFontSz" val="5" fact="NaN" max="NaN"/>
          </dgm:ruleLst>
        </dgm:layoutNode>
      </dgm:layoutNode>
      <dgm:choose name="Name15">
        <dgm:if name="Name16" axis="self" ptType="node" func="revPos" op="gte" val="2">
          <dgm:layoutNode name="aSpace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if>
        <dgm:else name="Name17"/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2948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1698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5848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49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0922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3039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2078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2382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8009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404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7618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C27AF-FE04-4CBB-98F5-9745947D1ACC}" type="datetimeFigureOut">
              <a:rPr lang="en-GB" smtClean="0"/>
              <a:t>19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07153-5A13-4A3A-962F-CE4898445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6186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Diagram 2"/>
          <p:cNvGraphicFramePr/>
          <p:nvPr>
            <p:extLst>
              <p:ext uri="{D42A27DB-BD31-4B8C-83A1-F6EECF244321}">
                <p14:modId xmlns:p14="http://schemas.microsoft.com/office/powerpoint/2010/main" val="3407043364"/>
              </p:ext>
            </p:extLst>
          </p:nvPr>
        </p:nvGraphicFramePr>
        <p:xfrm>
          <a:off x="408616" y="436419"/>
          <a:ext cx="10190111" cy="669174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CB0ABAAF-9EEF-4C1F-8567-B4347554F055}"/>
              </a:ext>
            </a:extLst>
          </p:cNvPr>
          <p:cNvSpPr txBox="1"/>
          <p:nvPr/>
        </p:nvSpPr>
        <p:spPr>
          <a:xfrm>
            <a:off x="10637880" y="2980534"/>
            <a:ext cx="1470992" cy="18158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GB" sz="1600" dirty="0"/>
              <a:t>Data collected on the </a:t>
            </a:r>
            <a:r>
              <a:rPr lang="en-GB" sz="1600" dirty="0" smtClean="0"/>
              <a:t>Web </a:t>
            </a:r>
            <a:r>
              <a:rPr lang="en-GB" sz="1600" dirty="0" smtClean="0"/>
              <a:t>app </a:t>
            </a:r>
            <a:r>
              <a:rPr lang="en-GB" sz="1600" dirty="0"/>
              <a:t>is stored securely at </a:t>
            </a:r>
            <a:r>
              <a:rPr lang="en-GB" sz="1600" dirty="0" err="1"/>
              <a:t>UKCloud</a:t>
            </a:r>
            <a:r>
              <a:rPr lang="en-GB" sz="1600" dirty="0"/>
              <a:t> in partnership with DH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6CE12ED-08F6-4707-A979-BF08D41E0406}"/>
              </a:ext>
            </a:extLst>
          </p:cNvPr>
          <p:cNvSpPr txBox="1"/>
          <p:nvPr/>
        </p:nvSpPr>
        <p:spPr>
          <a:xfrm>
            <a:off x="636320" y="1417981"/>
            <a:ext cx="2345419" cy="5847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1. Health professional enters </a:t>
            </a:r>
            <a:r>
              <a:rPr lang="en-GB" sz="1600" dirty="0" smtClean="0"/>
              <a:t>data into </a:t>
            </a:r>
            <a:r>
              <a:rPr lang="en-GB" sz="1600" dirty="0" smtClean="0"/>
              <a:t>Web </a:t>
            </a:r>
            <a:r>
              <a:rPr lang="en-GB" sz="1600" dirty="0" smtClean="0"/>
              <a:t>app</a:t>
            </a:r>
            <a:endParaRPr lang="en-GB" sz="16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A8D5F7A-5F8A-4301-8808-BA4FAE553224}"/>
              </a:ext>
            </a:extLst>
          </p:cNvPr>
          <p:cNvSpPr txBox="1"/>
          <p:nvPr/>
        </p:nvSpPr>
        <p:spPr>
          <a:xfrm>
            <a:off x="4194528" y="1453454"/>
            <a:ext cx="2219524" cy="5847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2. Patient enters </a:t>
            </a:r>
            <a:r>
              <a:rPr lang="en-GB" sz="1600" dirty="0" smtClean="0"/>
              <a:t>data into </a:t>
            </a:r>
            <a:r>
              <a:rPr lang="en-GB" sz="1600" dirty="0" smtClean="0"/>
              <a:t>Web </a:t>
            </a:r>
            <a:r>
              <a:rPr lang="en-GB" sz="1600" dirty="0" smtClean="0"/>
              <a:t>app</a:t>
            </a:r>
            <a:endParaRPr lang="en-GB" sz="16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30AB396-35D5-48BA-84A1-F81A8E6C4658}"/>
              </a:ext>
            </a:extLst>
          </p:cNvPr>
          <p:cNvSpPr txBox="1"/>
          <p:nvPr/>
        </p:nvSpPr>
        <p:spPr>
          <a:xfrm>
            <a:off x="7626841" y="1435917"/>
            <a:ext cx="2524324" cy="5847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600" dirty="0"/>
              <a:t>3. Health professional enters </a:t>
            </a:r>
            <a:r>
              <a:rPr lang="en-GB" sz="1600" dirty="0" smtClean="0"/>
              <a:t>data into </a:t>
            </a:r>
            <a:r>
              <a:rPr lang="en-GB" sz="1600" dirty="0" smtClean="0"/>
              <a:t>Web </a:t>
            </a:r>
            <a:r>
              <a:rPr lang="en-GB" sz="1600" dirty="0" smtClean="0"/>
              <a:t>app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1767730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8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ringer, Maria</dc:creator>
  <cp:lastModifiedBy>Woringer, Maria</cp:lastModifiedBy>
  <cp:revision>4</cp:revision>
  <dcterms:created xsi:type="dcterms:W3CDTF">2018-02-09T12:14:15Z</dcterms:created>
  <dcterms:modified xsi:type="dcterms:W3CDTF">2018-11-19T12:49:47Z</dcterms:modified>
</cp:coreProperties>
</file>